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0977E5C-9FCC-9D1E-EA54-15F70A668E72}" name="Empey, Kerry McGarr" initials="EKM" userId="S::KME33@pitt.edu::23a7e9ae-7bc8-420b-a180-b98e92b93130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37373"/>
    <a:srgbClr val="7B41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978"/>
    <p:restoredTop sz="97314" autoAdjust="0"/>
  </p:normalViewPr>
  <p:slideViewPr>
    <p:cSldViewPr snapToGrid="0">
      <p:cViewPr varScale="1">
        <p:scale>
          <a:sx n="107" d="100"/>
          <a:sy n="107" d="100"/>
        </p:scale>
        <p:origin x="120" y="1086"/>
      </p:cViewPr>
      <p:guideLst/>
    </p:cSldViewPr>
  </p:slideViewPr>
  <p:notesTextViewPr>
    <p:cViewPr>
      <p:scale>
        <a:sx n="150" d="100"/>
        <a:sy n="15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B42B50-9E91-3A4F-A9EB-407A93515923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3E1671-2674-FC4F-9D16-A2F2F1D2F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869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3E1671-2674-FC4F-9D16-A2F2F1D2FFD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7084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F95B5C-27A8-AE2A-8671-47787DD167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6BF628A-F26E-BE13-4240-F44A1A2E86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D67620-EB3E-961A-81C5-35B28D023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570E6E-469A-0FA4-DC26-B309BF5C3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D895EC-04E6-275A-DD86-3B2C43415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268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B024D2-BF3A-3B80-96C3-ED07C068CA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9BFCA4-C88F-0177-BD62-5FC2381CD0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FF009D-60FA-E4C7-72EE-4742FA72F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D3B25F-3E19-868A-0D7C-E360DAE6A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2ED40B-1560-CA6E-CF73-E15253732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174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7941ECD-652E-6D19-E290-3C3F6FD366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ED00CB-779E-1BFC-CF88-51D0050E49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A4112F-ED67-1FC6-DEFE-36E8D94FA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C4D3CF-379F-0A53-7AB0-51BD76349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F0D22F-971D-ACD3-EEAD-18B7599BF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438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00A8D-1906-6F8D-BDAA-7F938ED34D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D3AFE4-1263-51A2-27BD-5D56E29D41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E9978B-2CF5-FDE8-D696-C8C7933CB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9B6CE-31C7-E4D2-2E6F-7F1007335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1EB8EE-79A0-963B-F2DB-8030F261D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801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22C9B-2CBE-CBA1-D342-83CEF5F4FB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5B436B-8214-1539-DD50-3A4AC57DBA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122389-E69D-ABBA-57B1-FAFE60A90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FA7958-4B92-CE75-63A4-EB4C8C216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5F1392-FF63-8952-EDA5-DCAE03920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290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E9A1E-E595-0DCD-26E8-3A2248C6C5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CCAD9A-247B-848A-DC02-DDF42FDEC5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8BC706-26A5-DBF1-22D1-E152A7584D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1DAC91-3AD4-AAB7-5C1E-2405A7AB9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7CDF2E-12A9-4860-5541-0B3B1A384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69BDE7-6D68-8290-767C-D227048A1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499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238A7-E705-1676-1045-4B72E450A2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0B1C32-51E2-5385-9EDC-94CC62B18E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51C3B3-A020-F85F-7216-BB7ED40640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A0DFEF9-6F48-F080-DDCB-BE9D124DDC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C846C20-BD4C-E6FB-10E3-C68C333BAD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F9AAB8-01A2-5361-3700-F5CD869AD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5B8440E-D0C6-A61C-A5D3-3285E7381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36DD588-BBAE-6598-0D71-7A3DFFA465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808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C62BEE-D52A-FC91-3350-BEEC75EC1B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5CE82B2-3149-B60F-664F-106C1A77D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E9B2B1-B5C9-01DA-5DA8-A067E16C1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464EE8F-3AD3-9D8E-8DB6-714EEE213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344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B05C4CD-2837-0D1F-7D64-ABC2CE5CF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7D94DB2-5F66-C5E3-4547-0E19DFA99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E23B840-658F-C9E1-2E83-06972A629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870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0D9777-F003-BE3D-C6BC-103A23369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0F732D-EAE8-47E6-9B3C-49EECE58E4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AFCCB1-513B-D71A-E41C-9436F2565C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0EB9AA-D47B-C698-9AB3-553283330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A6EBA4-A958-BD96-8095-A6EC6C085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D21D39-9A5E-AAC4-B26D-93ABCC9AD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209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741373-DFAF-4014-E514-0805C3890A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54FCF4-38AF-D149-6553-2EDAB1C883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D0AF84-FA5B-3283-B9A8-CC3094B50B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9EA0B2-1885-5D0C-07AC-1A400F34E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FF8DC5-5ADE-4877-AF71-BB1E9905B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C7DF73-24B3-41B2-8123-622DE2BFC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16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FD80FB-56CC-C580-6672-6223C9D77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E617B5-632C-62BA-B13B-6E16FBB0F6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33D8DD-4573-71CA-95AC-9811242CA1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4CDFA-6446-5848-9BB0-0AD147BA8F89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C369C1-3534-D29C-1DE3-53C30415C0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5A3A08-E30B-0511-E5D1-3749D4B281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003B9-3146-B74E-8961-FBE7C1F121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667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A6753D6-889B-54E3-D893-783C4B9A5525}"/>
              </a:ext>
            </a:extLst>
          </p:cNvPr>
          <p:cNvSpPr txBox="1"/>
          <p:nvPr/>
        </p:nvSpPr>
        <p:spPr>
          <a:xfrm>
            <a:off x="1099641" y="5807898"/>
            <a:ext cx="9992717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. Cleaved IL-33 is increased in the lungs of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PreF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offspring. </a:t>
            </a:r>
            <a:r>
              <a:rPr lang="en-US" sz="1400" b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Veh and </a:t>
            </a:r>
            <a:r>
              <a:rPr lang="en-US" sz="1400" b="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PreF</a:t>
            </a:r>
            <a:r>
              <a:rPr lang="en-US" sz="1400" b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djuvanted with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um) </a:t>
            </a:r>
            <a:r>
              <a:rPr lang="en-US" sz="1400" b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ups were generated and infected as described in Figure 7. </a:t>
            </a:r>
            <a:r>
              <a:rPr 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At 1dpe, upper right lung homogenate was analyzed for cleaved IL-33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-B)</a:t>
            </a:r>
            <a:r>
              <a:rPr 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. The frequency of MHCII</a:t>
            </a:r>
            <a:r>
              <a:rPr lang="en-US" sz="1400" b="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ILC2s was quantified from the lower right lung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. Data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re represented as mean ± SEM (n=5 mice per group). Statistical significance was calculated using an unpaired t-test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B-C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**p ≤ 0.01 and ***p ≤ 0.001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2BA6A6B-E4D9-C0B4-8673-2437989C6507}"/>
              </a:ext>
            </a:extLst>
          </p:cNvPr>
          <p:cNvGrpSpPr/>
          <p:nvPr/>
        </p:nvGrpSpPr>
        <p:grpSpPr>
          <a:xfrm>
            <a:off x="2590800" y="95995"/>
            <a:ext cx="7576346" cy="5711903"/>
            <a:chOff x="2386334" y="575187"/>
            <a:chExt cx="7655306" cy="5891691"/>
          </a:xfrm>
        </p:grpSpPr>
        <p:pic>
          <p:nvPicPr>
            <p:cNvPr id="9" name="Picture 8" descr="Diagram, schematic&#10;&#10;Description automatically generated">
              <a:extLst>
                <a:ext uri="{FF2B5EF4-FFF2-40B4-BE49-F238E27FC236}">
                  <a16:creationId xmlns:a16="http://schemas.microsoft.com/office/drawing/2014/main" id="{518C5006-D15D-E0AB-BFF6-41AFB05EA3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57413"/>
            <a:stretch/>
          </p:blipFill>
          <p:spPr>
            <a:xfrm>
              <a:off x="2386334" y="575187"/>
              <a:ext cx="7655306" cy="2753541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C763DB1-3163-74A1-EE14-940D1203CD02}"/>
                </a:ext>
              </a:extLst>
            </p:cNvPr>
            <p:cNvSpPr txBox="1"/>
            <p:nvPr/>
          </p:nvSpPr>
          <p:spPr>
            <a:xfrm>
              <a:off x="6597448" y="2932739"/>
              <a:ext cx="96356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2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PreF</a:t>
              </a:r>
              <a:endParaRPr lang="en-US" sz="2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DA1D22B-EE2B-65A4-846A-A97F021D251D}"/>
                </a:ext>
              </a:extLst>
            </p:cNvPr>
            <p:cNvSpPr txBox="1"/>
            <p:nvPr/>
          </p:nvSpPr>
          <p:spPr>
            <a:xfrm>
              <a:off x="4146314" y="2932739"/>
              <a:ext cx="96356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2200" b="1" dirty="0">
                  <a:latin typeface="Arial" panose="020B0604020202020204" pitchFamily="34" charset="0"/>
                  <a:cs typeface="Arial" panose="020B0604020202020204" pitchFamily="34" charset="0"/>
                </a:rPr>
                <a:t>mVeh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C2846B9-FAF8-1EA1-7419-0F1A314926C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46088" y="3529273"/>
              <a:ext cx="2277469" cy="293760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697C1A7F-5671-FBFA-49C9-242E430E8B0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096000" y="3529273"/>
              <a:ext cx="1952955" cy="2853813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1047DEE-4B01-3F79-CCAC-B823059FE880}"/>
                </a:ext>
              </a:extLst>
            </p:cNvPr>
            <p:cNvSpPr txBox="1"/>
            <p:nvPr/>
          </p:nvSpPr>
          <p:spPr>
            <a:xfrm>
              <a:off x="4464026" y="3471838"/>
              <a:ext cx="32813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F5D8D8C-D2AC-E709-04EC-E39D250B27D6}"/>
                </a:ext>
              </a:extLst>
            </p:cNvPr>
            <p:cNvSpPr txBox="1"/>
            <p:nvPr/>
          </p:nvSpPr>
          <p:spPr>
            <a:xfrm>
              <a:off x="6741495" y="3471838"/>
              <a:ext cx="32813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43437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06</TotalTime>
  <Words>104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Kosanovich</dc:creator>
  <cp:lastModifiedBy>Empey, Kerry McGarr</cp:lastModifiedBy>
  <cp:revision>73</cp:revision>
  <dcterms:created xsi:type="dcterms:W3CDTF">2023-03-22T12:55:43Z</dcterms:created>
  <dcterms:modified xsi:type="dcterms:W3CDTF">2024-04-19T12:10:31Z</dcterms:modified>
</cp:coreProperties>
</file>